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avi" ContentType="video/x-msvide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11" autoAdjust="0"/>
    <p:restoredTop sz="94660"/>
  </p:normalViewPr>
  <p:slideViewPr>
    <p:cSldViewPr snapToGrid="0">
      <p:cViewPr>
        <p:scale>
          <a:sx n="138" d="100"/>
          <a:sy n="138" d="100"/>
        </p:scale>
        <p:origin x="1040" y="-28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FFBE0-AD57-4BCF-B792-88B2F2508053}" type="datetimeFigureOut">
              <a:rPr lang="en-GB" smtClean="0"/>
              <a:t>13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74F86-B450-48D4-AFDD-3F3A2CBC180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29586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FFBE0-AD57-4BCF-B792-88B2F2508053}" type="datetimeFigureOut">
              <a:rPr lang="en-GB" smtClean="0"/>
              <a:t>13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74F86-B450-48D4-AFDD-3F3A2CBC180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27272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FFBE0-AD57-4BCF-B792-88B2F2508053}" type="datetimeFigureOut">
              <a:rPr lang="en-GB" smtClean="0"/>
              <a:t>13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74F86-B450-48D4-AFDD-3F3A2CBC180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98385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FFBE0-AD57-4BCF-B792-88B2F2508053}" type="datetimeFigureOut">
              <a:rPr lang="en-GB" smtClean="0"/>
              <a:t>13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74F86-B450-48D4-AFDD-3F3A2CBC180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23772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FFBE0-AD57-4BCF-B792-88B2F2508053}" type="datetimeFigureOut">
              <a:rPr lang="en-GB" smtClean="0"/>
              <a:t>13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74F86-B450-48D4-AFDD-3F3A2CBC180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52978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FFBE0-AD57-4BCF-B792-88B2F2508053}" type="datetimeFigureOut">
              <a:rPr lang="en-GB" smtClean="0"/>
              <a:t>13/0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74F86-B450-48D4-AFDD-3F3A2CBC180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89079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FFBE0-AD57-4BCF-B792-88B2F2508053}" type="datetimeFigureOut">
              <a:rPr lang="en-GB" smtClean="0"/>
              <a:t>13/01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74F86-B450-48D4-AFDD-3F3A2CBC180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72726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FFBE0-AD57-4BCF-B792-88B2F2508053}" type="datetimeFigureOut">
              <a:rPr lang="en-GB" smtClean="0"/>
              <a:t>13/01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74F86-B450-48D4-AFDD-3F3A2CBC180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37441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FFBE0-AD57-4BCF-B792-88B2F2508053}" type="datetimeFigureOut">
              <a:rPr lang="en-GB" smtClean="0"/>
              <a:t>13/01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74F86-B450-48D4-AFDD-3F3A2CBC180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74635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FFBE0-AD57-4BCF-B792-88B2F2508053}" type="datetimeFigureOut">
              <a:rPr lang="en-GB" smtClean="0"/>
              <a:t>13/0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74F86-B450-48D4-AFDD-3F3A2CBC180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49525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FFBE0-AD57-4BCF-B792-88B2F2508053}" type="datetimeFigureOut">
              <a:rPr lang="en-GB" smtClean="0"/>
              <a:t>13/01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274F86-B450-48D4-AFDD-3F3A2CBC180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06137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6FFBE0-AD57-4BCF-B792-88B2F2508053}" type="datetimeFigureOut">
              <a:rPr lang="en-GB" smtClean="0"/>
              <a:t>13/01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274F86-B450-48D4-AFDD-3F3A2CBC180A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25040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Angular dependence of the input SHG intensity from thaumatin crystals (from0-90degrees)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694250" y="903288"/>
            <a:ext cx="5719249" cy="5547184"/>
          </a:xfrm>
          <a:prstGeom prst="rect">
            <a:avLst/>
          </a:prstGeom>
        </p:spPr>
      </p:pic>
      <p:sp>
        <p:nvSpPr>
          <p:cNvPr id="6" name="Rectangle 5"/>
          <p:cNvSpPr/>
          <p:nvPr/>
        </p:nvSpPr>
        <p:spPr>
          <a:xfrm>
            <a:off x="694249" y="7315881"/>
            <a:ext cx="5401751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GB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694250" y="6726989"/>
            <a:ext cx="5719249" cy="129266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Video 1</a:t>
            </a:r>
          </a:p>
          <a:p>
            <a:pPr algn="just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Angular dependence of recorded SHG intensities applying a suspension of thaumatin crystals and changing the polarization plane in steps of 10° from 0-90°  by rotating a half-wave plate (HWP) in the MPM system</a:t>
            </a:r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  <a:p>
            <a:pPr algn="just"/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experiment is confirming the potential of the SHG instrumentation in the MPM system to detect micro-sized crystals and to analyze the optical anisotropy of crystalline samples. </a:t>
            </a:r>
          </a:p>
          <a:p>
            <a:pPr algn="just"/>
            <a:endParaRPr lang="en-GB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5892451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69</Words>
  <Application>Microsoft Macintosh PowerPoint</Application>
  <PresentationFormat>Breitbild</PresentationFormat>
  <Paragraphs>3</Paragraphs>
  <Slides>1</Slides>
  <Notes>0</Notes>
  <HiddenSlides>0</HiddenSlides>
  <MMClips>1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-Präsentation</vt:lpstr>
    </vt:vector>
  </TitlesOfParts>
  <Company>Universität Hamburg - Fachbereich Chemie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indows User</dc:creator>
  <cp:lastModifiedBy>Christian Betzel</cp:lastModifiedBy>
  <cp:revision>5</cp:revision>
  <dcterms:created xsi:type="dcterms:W3CDTF">2020-01-13T13:47:19Z</dcterms:created>
  <dcterms:modified xsi:type="dcterms:W3CDTF">2020-01-13T14:58:24Z</dcterms:modified>
</cp:coreProperties>
</file>